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  <p:sldId id="256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37" d="100"/>
          <a:sy n="137" d="100"/>
        </p:scale>
        <p:origin x="-1216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71F68-9767-9B46-81B6-654B30E263FE}" type="datetimeFigureOut">
              <a:rPr lang="en-US" smtClean="0"/>
              <a:t>13/0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6058F-2211-4645-9C25-782E88B514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335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71F68-9767-9B46-81B6-654B30E263FE}" type="datetimeFigureOut">
              <a:rPr lang="en-US" smtClean="0"/>
              <a:t>13/0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6058F-2211-4645-9C25-782E88B514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1174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71F68-9767-9B46-81B6-654B30E263FE}" type="datetimeFigureOut">
              <a:rPr lang="en-US" smtClean="0"/>
              <a:t>13/0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6058F-2211-4645-9C25-782E88B514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4373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71F68-9767-9B46-81B6-654B30E263FE}" type="datetimeFigureOut">
              <a:rPr lang="en-US" smtClean="0"/>
              <a:t>13/0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6058F-2211-4645-9C25-782E88B514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114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71F68-9767-9B46-81B6-654B30E263FE}" type="datetimeFigureOut">
              <a:rPr lang="en-US" smtClean="0"/>
              <a:t>13/0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6058F-2211-4645-9C25-782E88B514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025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71F68-9767-9B46-81B6-654B30E263FE}" type="datetimeFigureOut">
              <a:rPr lang="en-US" smtClean="0"/>
              <a:t>13/04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6058F-2211-4645-9C25-782E88B514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50678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71F68-9767-9B46-81B6-654B30E263FE}" type="datetimeFigureOut">
              <a:rPr lang="en-US" smtClean="0"/>
              <a:t>13/04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6058F-2211-4645-9C25-782E88B514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0290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71F68-9767-9B46-81B6-654B30E263FE}" type="datetimeFigureOut">
              <a:rPr lang="en-US" smtClean="0"/>
              <a:t>13/04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6058F-2211-4645-9C25-782E88B514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85341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71F68-9767-9B46-81B6-654B30E263FE}" type="datetimeFigureOut">
              <a:rPr lang="en-US" smtClean="0"/>
              <a:t>13/04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6058F-2211-4645-9C25-782E88B514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7727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71F68-9767-9B46-81B6-654B30E263FE}" type="datetimeFigureOut">
              <a:rPr lang="en-US" smtClean="0"/>
              <a:t>13/04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6058F-2211-4645-9C25-782E88B514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2848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71F68-9767-9B46-81B6-654B30E263FE}" type="datetimeFigureOut">
              <a:rPr lang="en-US" smtClean="0"/>
              <a:t>13/04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6058F-2211-4645-9C25-782E88B514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3684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071F68-9767-9B46-81B6-654B30E263FE}" type="datetimeFigureOut">
              <a:rPr lang="en-US" smtClean="0"/>
              <a:t>13/0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86058F-2211-4645-9C25-782E88B514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769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Module_2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58520"/>
            <a:ext cx="9144000" cy="550606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379596" y="16117"/>
            <a:ext cx="2648081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/>
                <a:cs typeface="Arial"/>
              </a:rPr>
              <a:t>Supplement</a:t>
            </a:r>
          </a:p>
          <a:p>
            <a:pPr algn="ctr"/>
            <a:endParaRPr lang="en-US" sz="800" dirty="0">
              <a:latin typeface="Arial"/>
              <a:cs typeface="Arial"/>
            </a:endParaRPr>
          </a:p>
          <a:p>
            <a:pPr algn="ctr"/>
            <a:r>
              <a:rPr lang="en-US" sz="2400" dirty="0" smtClean="0">
                <a:latin typeface="Arial"/>
                <a:cs typeface="Arial"/>
              </a:rPr>
              <a:t>Module </a:t>
            </a:r>
            <a:r>
              <a:rPr lang="en-US" sz="2400" dirty="0" smtClean="0">
                <a:latin typeface="Arial"/>
                <a:cs typeface="Arial"/>
              </a:rPr>
              <a:t>2 </a:t>
            </a:r>
            <a:r>
              <a:rPr lang="en-US" sz="2400" dirty="0" err="1" smtClean="0">
                <a:latin typeface="Arial"/>
                <a:cs typeface="Arial"/>
              </a:rPr>
              <a:t>ClueGO</a:t>
            </a:r>
            <a:endParaRPr lang="en-US" sz="2400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453662" y="6451663"/>
            <a:ext cx="26612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S3_met_PC1_genewise</a:t>
            </a:r>
          </a:p>
        </p:txBody>
      </p:sp>
    </p:spTree>
    <p:extLst>
      <p:ext uri="{BB962C8B-B14F-4D97-AF65-F5344CB8AC3E}">
        <p14:creationId xmlns:p14="http://schemas.microsoft.com/office/powerpoint/2010/main" val="19427603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453662" y="6451663"/>
            <a:ext cx="26612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S3_met_PC1_genewise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294011" y="442577"/>
            <a:ext cx="2819251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/>
                <a:cs typeface="Arial"/>
              </a:rPr>
              <a:t>Supplement</a:t>
            </a:r>
          </a:p>
          <a:p>
            <a:pPr algn="ctr"/>
            <a:endParaRPr lang="en-US" sz="800" dirty="0">
              <a:latin typeface="Arial"/>
              <a:cs typeface="Arial"/>
            </a:endParaRPr>
          </a:p>
          <a:p>
            <a:pPr algn="ctr"/>
            <a:r>
              <a:rPr lang="en-US" sz="2400" dirty="0" smtClean="0">
                <a:latin typeface="Arial"/>
                <a:cs typeface="Arial"/>
              </a:rPr>
              <a:t>Module 18 </a:t>
            </a:r>
            <a:r>
              <a:rPr lang="en-US" sz="2400" dirty="0" err="1" smtClean="0">
                <a:latin typeface="Arial"/>
                <a:cs typeface="Arial"/>
              </a:rPr>
              <a:t>ClueGO</a:t>
            </a:r>
            <a:endParaRPr lang="en-US" sz="2400" dirty="0">
              <a:latin typeface="Arial"/>
              <a:cs typeface="Arial"/>
            </a:endParaRPr>
          </a:p>
        </p:txBody>
      </p:sp>
      <p:pic>
        <p:nvPicPr>
          <p:cNvPr id="6" name="Picture 5" descr="Rplot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186" y="2052319"/>
            <a:ext cx="8930773" cy="34849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04223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Rplot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68400"/>
            <a:ext cx="9144000" cy="451980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466731" y="78490"/>
            <a:ext cx="2819251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/>
                <a:cs typeface="Arial"/>
              </a:rPr>
              <a:t>Supplement</a:t>
            </a:r>
          </a:p>
          <a:p>
            <a:pPr algn="ctr"/>
            <a:endParaRPr lang="en-US" sz="800" dirty="0">
              <a:latin typeface="Arial"/>
              <a:cs typeface="Arial"/>
            </a:endParaRPr>
          </a:p>
          <a:p>
            <a:pPr algn="ctr"/>
            <a:r>
              <a:rPr lang="en-US" sz="2400" dirty="0" smtClean="0">
                <a:latin typeface="Arial"/>
                <a:cs typeface="Arial"/>
              </a:rPr>
              <a:t>Module 52 </a:t>
            </a:r>
            <a:r>
              <a:rPr lang="en-US" sz="2400" dirty="0" err="1" smtClean="0">
                <a:latin typeface="Arial"/>
                <a:cs typeface="Arial"/>
              </a:rPr>
              <a:t>ClueGO</a:t>
            </a:r>
            <a:endParaRPr lang="en-US" sz="2400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467698" y="6451663"/>
            <a:ext cx="26612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S3_met_PC1_genewise</a:t>
            </a:r>
            <a:endParaRPr lang="en-US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92354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15</Words>
  <Application>Microsoft Macintosh PowerPoint</Application>
  <PresentationFormat>On-screen Show (4:3)</PresentationFormat>
  <Paragraphs>12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m Kaput</dc:creator>
  <cp:lastModifiedBy>Jim Kaput</cp:lastModifiedBy>
  <cp:revision>3</cp:revision>
  <dcterms:created xsi:type="dcterms:W3CDTF">2013-10-10T17:07:49Z</dcterms:created>
  <dcterms:modified xsi:type="dcterms:W3CDTF">2014-04-13T10:42:48Z</dcterms:modified>
</cp:coreProperties>
</file>